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2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F83A4EB-709B-2C4D-B476-CF3C5171216B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576301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3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798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0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6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767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1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&lt; 0.000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366900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400" b="1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 line treatment-TMB interaction models from Figure 2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The (A) TTNT and (B) OS interaction models are shown for for propensity adjusted analyses in Figure 2.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FE620B5-EDB7-444A-AA47-0DE6A1496C72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1955335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0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7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6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88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5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7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828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2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02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E08C7FA-82EC-2044-91F9-0227F815F58E}"/>
              </a:ext>
            </a:extLst>
          </p:cNvPr>
          <p:cNvSpPr txBox="1"/>
          <p:nvPr/>
        </p:nvSpPr>
        <p:spPr>
          <a:xfrm>
            <a:off x="5581038" y="490654"/>
            <a:ext cx="4908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9C30823-36CD-0A4A-A9F2-C547B7D5334B}"/>
              </a:ext>
            </a:extLst>
          </p:cNvPr>
          <p:cNvSpPr txBox="1"/>
          <p:nvPr/>
        </p:nvSpPr>
        <p:spPr>
          <a:xfrm>
            <a:off x="5581038" y="1892747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648518509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0</Words>
  <Application>Microsoft Macintosh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5</cp:revision>
  <dcterms:created xsi:type="dcterms:W3CDTF">2022-06-12T16:24:02Z</dcterms:created>
  <dcterms:modified xsi:type="dcterms:W3CDTF">2022-08-13T14:33:11Z</dcterms:modified>
</cp:coreProperties>
</file>